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9144000" cy="6858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54"/>
  </p:normalViewPr>
  <p:slideViewPr>
    <p:cSldViewPr snapToGrid="0" snapToObjects="1">
      <p:cViewPr varScale="1">
        <p:scale>
          <a:sx n="99" d="100"/>
          <a:sy n="99" d="100"/>
        </p:scale>
        <p:origin x="1904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276B8D-DBC4-E94D-A227-DA78401E6DD5}" type="datetimeFigureOut">
              <a:rPr lang="en-US" smtClean="0"/>
              <a:t>10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FEDFB-94BC-884E-A620-789DC5A5B7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2030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276B8D-DBC4-E94D-A227-DA78401E6DD5}" type="datetimeFigureOut">
              <a:rPr lang="en-US" smtClean="0"/>
              <a:t>10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FEDFB-94BC-884E-A620-789DC5A5B7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95790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276B8D-DBC4-E94D-A227-DA78401E6DD5}" type="datetimeFigureOut">
              <a:rPr lang="en-US" smtClean="0"/>
              <a:t>10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FEDFB-94BC-884E-A620-789DC5A5B7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19336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276B8D-DBC4-E94D-A227-DA78401E6DD5}" type="datetimeFigureOut">
              <a:rPr lang="en-US" smtClean="0"/>
              <a:t>10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FEDFB-94BC-884E-A620-789DC5A5B7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4331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276B8D-DBC4-E94D-A227-DA78401E6DD5}" type="datetimeFigureOut">
              <a:rPr lang="en-US" smtClean="0"/>
              <a:t>10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FEDFB-94BC-884E-A620-789DC5A5B7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47837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276B8D-DBC4-E94D-A227-DA78401E6DD5}" type="datetimeFigureOut">
              <a:rPr lang="en-US" smtClean="0"/>
              <a:t>10/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FEDFB-94BC-884E-A620-789DC5A5B7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33366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276B8D-DBC4-E94D-A227-DA78401E6DD5}" type="datetimeFigureOut">
              <a:rPr lang="en-US" smtClean="0"/>
              <a:t>10/2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FEDFB-94BC-884E-A620-789DC5A5B7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56055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276B8D-DBC4-E94D-A227-DA78401E6DD5}" type="datetimeFigureOut">
              <a:rPr lang="en-US" smtClean="0"/>
              <a:t>10/2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FEDFB-94BC-884E-A620-789DC5A5B7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88784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276B8D-DBC4-E94D-A227-DA78401E6DD5}" type="datetimeFigureOut">
              <a:rPr lang="en-US" smtClean="0"/>
              <a:t>10/2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FEDFB-94BC-884E-A620-789DC5A5B7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28477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276B8D-DBC4-E94D-A227-DA78401E6DD5}" type="datetimeFigureOut">
              <a:rPr lang="en-US" smtClean="0"/>
              <a:t>10/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FEDFB-94BC-884E-A620-789DC5A5B7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12004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276B8D-DBC4-E94D-A227-DA78401E6DD5}" type="datetimeFigureOut">
              <a:rPr lang="en-US" smtClean="0"/>
              <a:t>10/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FEDFB-94BC-884E-A620-789DC5A5B7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54137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276B8D-DBC4-E94D-A227-DA78401E6DD5}" type="datetimeFigureOut">
              <a:rPr lang="en-US" smtClean="0"/>
              <a:t>10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3FEDFB-94BC-884E-A620-789DC5A5B7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65000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B57BB15A-D94B-794A-9441-D8EA47F9449D}"/>
              </a:ext>
            </a:extLst>
          </p:cNvPr>
          <p:cNvSpPr txBox="1"/>
          <p:nvPr/>
        </p:nvSpPr>
        <p:spPr>
          <a:xfrm>
            <a:off x="0" y="6143518"/>
            <a:ext cx="1791131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05/04/2016</a:t>
            </a:r>
          </a:p>
          <a:p>
            <a:r>
              <a:rPr lang="en-US" sz="1400" dirty="0"/>
              <a:t>GRP78 ELISA on COPD</a:t>
            </a:r>
          </a:p>
          <a:p>
            <a:r>
              <a:rPr lang="en-US" sz="1400" dirty="0"/>
              <a:t>45 minute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9658658-6ECC-ED4F-AAEA-2F7C91ABA406}"/>
              </a:ext>
            </a:extLst>
          </p:cNvPr>
          <p:cNvSpPr txBox="1"/>
          <p:nvPr/>
        </p:nvSpPr>
        <p:spPr>
          <a:xfrm>
            <a:off x="0" y="-37344"/>
            <a:ext cx="4248279" cy="1446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S1: </a:t>
            </a:r>
            <a:r>
              <a:rPr lang="en-US" sz="1400" b="1" dirty="0"/>
              <a:t>High level of reproducibility in a</a:t>
            </a:r>
          </a:p>
          <a:p>
            <a:r>
              <a:rPr lang="en-US" sz="1400" b="1" dirty="0"/>
              <a:t>representative ELISA assay to measure GRP78</a:t>
            </a:r>
          </a:p>
          <a:p>
            <a:r>
              <a:rPr lang="en-US" sz="1400" b="1" dirty="0"/>
              <a:t>autoantibodies in COPD plasma. </a:t>
            </a:r>
            <a:r>
              <a:rPr lang="en-US" sz="1400" dirty="0"/>
              <a:t>The plasma samples </a:t>
            </a:r>
          </a:p>
          <a:p>
            <a:r>
              <a:rPr lang="en-US" sz="1400" dirty="0"/>
              <a:t>were tested in duplicate. The shown Standard </a:t>
            </a:r>
          </a:p>
          <a:p>
            <a:r>
              <a:rPr lang="en-US" sz="1400" dirty="0"/>
              <a:t>Deviation (STDEV) estimates the degree of variation in </a:t>
            </a:r>
          </a:p>
          <a:p>
            <a:r>
              <a:rPr lang="en-US" sz="1400" dirty="0"/>
              <a:t>the ELISA results in one plasma sample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1FF26694-4FC8-ED43-9638-68ECC4156CE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38685" y="-37344"/>
            <a:ext cx="4969445" cy="89937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559078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</TotalTime>
  <Words>56</Words>
  <Application>Microsoft Macintosh PowerPoint</Application>
  <PresentationFormat>Letter Paper (8.5x11 in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ran Nguyen, Thi Kim</dc:creator>
  <cp:lastModifiedBy>Tran Nguyen, Thi Kim</cp:lastModifiedBy>
  <cp:revision>5</cp:revision>
  <cp:lastPrinted>2020-10-02T22:08:49Z</cp:lastPrinted>
  <dcterms:created xsi:type="dcterms:W3CDTF">2020-10-02T21:19:10Z</dcterms:created>
  <dcterms:modified xsi:type="dcterms:W3CDTF">2020-10-02T22:08:55Z</dcterms:modified>
</cp:coreProperties>
</file>